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EE9A2A9-2CD4-4322-A1CE-3FCA86674C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A00B65BC-D98C-41C9-93DC-6FB325423D6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C268BB4-2B1B-4EFD-873D-6E305AE898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70C130D-B336-4A67-ABEE-22367BB6E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1FC517D-3E94-473B-90E9-51A26B82F0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5320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FDCA571-9662-499A-A9B9-4D7437FDB3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1757A5B-62A3-4574-AF2B-E4C5E4A1C5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F31D957-91A2-431A-863F-5BBF50061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4B777DA-62B8-40FF-982A-0E1D89299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65478B2-C02B-4B7F-B2E4-EB4A92133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291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B64F367-4219-4253-BC3D-C72E2A5B5B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510E338-4016-4A7A-AAF0-E4AD569E7B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0A6D684-4D21-4D36-8F98-BD932A4FD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D6D0340-55F6-42C6-A31D-6FB231C96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B30FB00-50C6-4E52-BE6E-8ED17C9EB0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7057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C5A8F0C-5046-4EFD-894E-A5675F6502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00C106C-AB0D-425D-89C0-634D8363EF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F30657F-0F5A-4A0C-925F-AFDC45A41B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B31C42E-FD32-460D-82E5-FF2A940CC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4FBDD35-2FEB-472B-976B-D637D79FB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5792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7E8B11E-0D3E-41E0-9C08-786C5CD0BF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F7BBFD8-EDC8-4B7B-AB28-7576198E0E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77B5F8A-0CF7-48F1-A2F7-16FFA5A750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B5B5DF-870E-43BE-8C18-595C3EFDA1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029D744-F640-484F-B3AF-DF2FAD94D9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3662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53A85F7-CB27-4167-A83C-AA6B5ECCD1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D04DEFE-5F44-421C-9041-5167783BD9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544D268-482B-4E83-81C4-8183C7C613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B2AE6A7-F42C-41A9-BD43-2A4A1950BC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67CC7AF-9DEC-40AA-8C4A-8B11F0FC5C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1B96171-0491-46A9-88E8-FBB63DE1ED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5399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9BBAF36-35E9-4ABD-A658-1EC8B7951D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C7AFA3E-B3EB-41CB-97D8-9D98946452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987B508-8DC6-490C-B646-F5D970423B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AB11E393-863F-45A5-8669-CDC3DD5DCC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7CDB996E-2F34-41A3-B53F-8CDE6F2963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E3649D23-AB12-4E20-8C8B-6B3FAA0666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E32F52CA-9EA9-45A6-87F0-331C31F3E7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34022620-CD77-45F8-9FFC-6D1E97E8B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889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7EAF1E1-8C09-401A-BDD3-149788DD47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C7CD27C1-A5FC-4430-9C4C-CD25F1364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4638ADDC-85FF-4ED8-9F9B-AD9623431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1B875CE6-36B6-40C6-80CE-D52CAC6F1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770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F2B77A1-13F0-4202-A962-1D6DE21BEA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0B715CC-C33F-408C-84D4-473BEEE22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560BE0F4-4C10-4CAC-B8D8-547B1D75E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8044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98BEE85-D98F-4DF1-8199-1C7D767EC7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C804BE3-BBBD-4DBA-BE61-1217AB86FB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2712B28-C8E2-4B4F-A6B4-39FA2A13A6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240DE2C-388E-4FF5-B595-1D4C21E16D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9A3D853-3902-43BE-B7DA-C59ACCF7C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DE6D3E3-C664-47DD-972D-6352EBF073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3154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318DEFA-0A0E-49AA-9DBD-601DE79C67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C6F8082-344A-4613-B86A-60D2657FB6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C019C90-36CA-4602-8959-3B5FBFBB74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AAC2BFA-D69A-429C-8BA0-009BFC2691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44314C5-D89E-483E-A75A-83D91D0F9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A238B2C-4A3A-4144-B73F-92139D388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0079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1DAA9CE8-C6CE-4810-BE41-37F375FB6A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FA107BE-8456-4C2F-9E9A-076E0F0678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BDA2D76-F8C2-4410-99F5-3A1C54C1EA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E7364AA-D7E5-4712-814A-563D9F864E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EC5E1A4-3A8E-4B50-8D9E-057A55707F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9118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5385941B-1717-48C3-9BE2-F2224D23E5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4864888"/>
              </p:ext>
            </p:extLst>
          </p:nvPr>
        </p:nvGraphicFramePr>
        <p:xfrm>
          <a:off x="631027" y="8996"/>
          <a:ext cx="10929947" cy="6840009"/>
        </p:xfrm>
        <a:graphic>
          <a:graphicData uri="http://schemas.openxmlformats.org/drawingml/2006/table">
            <a:tbl>
              <a:tblPr/>
              <a:tblGrid>
                <a:gridCol w="1032750">
                  <a:extLst>
                    <a:ext uri="{9D8B030D-6E8A-4147-A177-3AD203B41FA5}">
                      <a16:colId xmlns:a16="http://schemas.microsoft.com/office/drawing/2014/main" val="2913836575"/>
                    </a:ext>
                  </a:extLst>
                </a:gridCol>
                <a:gridCol w="910829">
                  <a:extLst>
                    <a:ext uri="{9D8B030D-6E8A-4147-A177-3AD203B41FA5}">
                      <a16:colId xmlns:a16="http://schemas.microsoft.com/office/drawing/2014/main" val="741568744"/>
                    </a:ext>
                  </a:extLst>
                </a:gridCol>
                <a:gridCol w="812813">
                  <a:extLst>
                    <a:ext uri="{9D8B030D-6E8A-4147-A177-3AD203B41FA5}">
                      <a16:colId xmlns:a16="http://schemas.microsoft.com/office/drawing/2014/main" val="3880565557"/>
                    </a:ext>
                  </a:extLst>
                </a:gridCol>
                <a:gridCol w="812813">
                  <a:extLst>
                    <a:ext uri="{9D8B030D-6E8A-4147-A177-3AD203B41FA5}">
                      <a16:colId xmlns:a16="http://schemas.microsoft.com/office/drawing/2014/main" val="1062418197"/>
                    </a:ext>
                  </a:extLst>
                </a:gridCol>
                <a:gridCol w="812813">
                  <a:extLst>
                    <a:ext uri="{9D8B030D-6E8A-4147-A177-3AD203B41FA5}">
                      <a16:colId xmlns:a16="http://schemas.microsoft.com/office/drawing/2014/main" val="1118146119"/>
                    </a:ext>
                  </a:extLst>
                </a:gridCol>
                <a:gridCol w="812813">
                  <a:extLst>
                    <a:ext uri="{9D8B030D-6E8A-4147-A177-3AD203B41FA5}">
                      <a16:colId xmlns:a16="http://schemas.microsoft.com/office/drawing/2014/main" val="1941113884"/>
                    </a:ext>
                  </a:extLst>
                </a:gridCol>
                <a:gridCol w="812813">
                  <a:extLst>
                    <a:ext uri="{9D8B030D-6E8A-4147-A177-3AD203B41FA5}">
                      <a16:colId xmlns:a16="http://schemas.microsoft.com/office/drawing/2014/main" val="795375349"/>
                    </a:ext>
                  </a:extLst>
                </a:gridCol>
                <a:gridCol w="812813">
                  <a:extLst>
                    <a:ext uri="{9D8B030D-6E8A-4147-A177-3AD203B41FA5}">
                      <a16:colId xmlns:a16="http://schemas.microsoft.com/office/drawing/2014/main" val="2903512020"/>
                    </a:ext>
                  </a:extLst>
                </a:gridCol>
                <a:gridCol w="810423">
                  <a:extLst>
                    <a:ext uri="{9D8B030D-6E8A-4147-A177-3AD203B41FA5}">
                      <a16:colId xmlns:a16="http://schemas.microsoft.com/office/drawing/2014/main" val="1703707004"/>
                    </a:ext>
                  </a:extLst>
                </a:gridCol>
                <a:gridCol w="812813">
                  <a:extLst>
                    <a:ext uri="{9D8B030D-6E8A-4147-A177-3AD203B41FA5}">
                      <a16:colId xmlns:a16="http://schemas.microsoft.com/office/drawing/2014/main" val="2868948663"/>
                    </a:ext>
                  </a:extLst>
                </a:gridCol>
                <a:gridCol w="1243127">
                  <a:extLst>
                    <a:ext uri="{9D8B030D-6E8A-4147-A177-3AD203B41FA5}">
                      <a16:colId xmlns:a16="http://schemas.microsoft.com/office/drawing/2014/main" val="1199475571"/>
                    </a:ext>
                  </a:extLst>
                </a:gridCol>
                <a:gridCol w="1243127">
                  <a:extLst>
                    <a:ext uri="{9D8B030D-6E8A-4147-A177-3AD203B41FA5}">
                      <a16:colId xmlns:a16="http://schemas.microsoft.com/office/drawing/2014/main" val="3127010044"/>
                    </a:ext>
                  </a:extLst>
                </a:gridCol>
              </a:tblGrid>
              <a:tr h="244578">
                <a:tc gridSpan="12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able 1.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The macromolecules (carbohydrates, proteins, and lipids), POC, PON, BPC concentrations, and associated calorific value of FM for total </a:t>
                      </a:r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&gt; 0.7 </a:t>
                      </a:r>
                      <a:r>
                        <a:rPr lang="en-US" altLang="ko-K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μm</a:t>
                      </a:r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POM at the JBS, 2015</a:t>
                      </a:r>
                    </a:p>
                  </a:txBody>
                  <a:tcPr marL="95774" marR="95774" marT="47887" marB="4788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35646320"/>
                  </a:ext>
                </a:extLst>
              </a:tr>
              <a:tr h="4601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eriod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ate (Julian date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rbohydrates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 L</a:t>
                      </a:r>
                      <a:r>
                        <a:rPr lang="en-US" sz="9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oteins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 L</a:t>
                      </a:r>
                      <a:r>
                        <a:rPr lang="en-US" sz="9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pids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 L</a:t>
                      </a:r>
                      <a:r>
                        <a:rPr lang="en-US" sz="9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ood Material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 L</a:t>
                      </a:r>
                      <a:r>
                        <a:rPr lang="en-US" sz="9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OC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 L</a:t>
                      </a:r>
                      <a:r>
                        <a:rPr lang="en-US" sz="9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ON</a:t>
                      </a:r>
                      <a:b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l-G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 L</a:t>
                      </a:r>
                      <a:r>
                        <a:rPr lang="en-US" sz="9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:N ratio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PC</a:t>
                      </a:r>
                      <a:b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l-G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 C L</a:t>
                      </a:r>
                      <a:r>
                        <a:rPr lang="en-US" sz="9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lorific value of FM</a:t>
                      </a:r>
                      <a:b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Kcal g</a:t>
                      </a:r>
                      <a:r>
                        <a:rPr lang="en-US" sz="9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lorific content of FM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Kcal m</a:t>
                      </a:r>
                      <a:r>
                        <a:rPr lang="en-US" sz="9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0366809"/>
                  </a:ext>
                </a:extLst>
              </a:tr>
              <a:tr h="191729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ce-free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eriod</a:t>
                      </a:r>
                    </a:p>
                  </a:txBody>
                  <a:tcPr marL="95774" marR="95774" marT="47887" marB="47887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2-02 (33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5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2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7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8128081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2-09 (40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4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0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85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1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8242604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2-18 (49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9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0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7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77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8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8384887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verage ± S.D.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2.9 ± 55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3.6 ± 8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3 ± 59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86.9 ± 194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2.8 ± 105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0 ± 0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 ± 1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2306776"/>
                  </a:ext>
                </a:extLst>
              </a:tr>
              <a:tr h="191729">
                <a:tc rowSpan="25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ce-coverd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eriod</a:t>
                      </a:r>
                    </a:p>
                  </a:txBody>
                  <a:tcPr marL="95774" marR="95774" marT="47887" marB="47887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4-06 (96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6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3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3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3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2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1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9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5230014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4-14 (104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8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7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8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9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3023336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4-21 (111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4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8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6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6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3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1547017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4-28 (118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5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9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6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7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8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7905907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5-06 (126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4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5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7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6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586411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5-12 (132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7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4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9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8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433431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5-19 (139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2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6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5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9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4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1267827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5-26 (146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3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4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4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57380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6-02 (153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7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6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0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25546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6-16 (167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1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4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7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9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2543004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6-24 (175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6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9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7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9174639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6-30 (181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4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5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5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9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0585015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7-17 (198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2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6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9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4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8275854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7-21 (202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2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6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4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1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5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45911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7-28 (209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1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6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9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3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5329496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8-06 (218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6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3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1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5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3806116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8-10 (222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3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6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2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2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2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6629129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8-28 (240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7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6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6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6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5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548131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9-02 (245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4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6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8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7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1416139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9-08 (251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6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5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7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6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9460632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9-15 (258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7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8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7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4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8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2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9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533913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9-22 (265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1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1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2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1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5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3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5474223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10-06 (279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3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1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5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9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7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6992373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10-20 (293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8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1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3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6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0279382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verage ± S.D.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9.0 ± 23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4 ± 7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4.7 ± 4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1.1 ± 24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8.8 ± 20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1 ± 5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2 ± 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7.7 ± 10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3 ± 0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 ± 0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2529293"/>
                  </a:ext>
                </a:extLst>
              </a:tr>
              <a:tr h="191729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ntire study period</a:t>
                      </a:r>
                    </a:p>
                  </a:txBody>
                  <a:tcPr marL="95774" marR="95774" marT="47887" marB="47887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n.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2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5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8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4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0185090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ax.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4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0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85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8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2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1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9031254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verage ± S.D.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5.0 ± 31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5 ± 49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3.1 ± 29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0.6 ± 103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8.8 ± 20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1 ± 5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2 ± 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3.9 ± 55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4 ± 0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 ± 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86724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78654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7</TotalTime>
  <Words>627</Words>
  <Application>Microsoft Office PowerPoint</Application>
  <PresentationFormat>와이드스크린</PresentationFormat>
  <Paragraphs>36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관우</dc:creator>
  <cp:lastModifiedBy>김관우</cp:lastModifiedBy>
  <cp:revision>30</cp:revision>
  <cp:lastPrinted>2020-04-13T04:29:49Z</cp:lastPrinted>
  <dcterms:created xsi:type="dcterms:W3CDTF">2020-04-13T03:47:55Z</dcterms:created>
  <dcterms:modified xsi:type="dcterms:W3CDTF">2021-01-21T01:20:52Z</dcterms:modified>
</cp:coreProperties>
</file>